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5"/>
  </p:notesMasterIdLst>
  <p:sldIdLst>
    <p:sldId id="274" r:id="rId2"/>
    <p:sldId id="275" r:id="rId3"/>
    <p:sldId id="276" r:id="rId4"/>
  </p:sldIdLst>
  <p:sldSz cx="6858000" cy="9906000" type="A4"/>
  <p:notesSz cx="6888163" cy="10018713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3143" userDrawn="1">
          <p15:clr>
            <a:srgbClr val="A4A3A4"/>
          </p15:clr>
        </p15:guide>
        <p15:guide id="2" pos="2183" userDrawn="1">
          <p15:clr>
            <a:srgbClr val="A4A3A4"/>
          </p15:clr>
        </p15:guide>
      </p15:sldGuideLst>
    </p:ext>
    <p:ext uri="http://customooxmlschemas.google.com/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go="http://customooxmlschemas.google.com/" r:id="rId16" roundtripDataSignature="AMtx7mh/0X9QH/tCkpYSgFALJwZJ61agrA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820" autoAdjust="0"/>
    <p:restoredTop sz="96370" autoAdjust="0"/>
  </p:normalViewPr>
  <p:slideViewPr>
    <p:cSldViewPr snapToGrid="0" snapToObjects="1" showGuides="1">
      <p:cViewPr varScale="1">
        <p:scale>
          <a:sx n="51" d="100"/>
          <a:sy n="51" d="100"/>
        </p:scale>
        <p:origin x="2316" y="72"/>
      </p:cViewPr>
      <p:guideLst>
        <p:guide orient="horz" pos="3143"/>
        <p:guide pos="218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customschemas.google.com/relationships/presentationmetadata" Target="metadata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5" Type="http://schemas.openxmlformats.org/officeDocument/2006/relationships/notesMaster" Target="notesMasters/notesMaster1.xml"/><Relationship Id="rId19" Type="http://schemas.openxmlformats.org/officeDocument/2006/relationships/theme" Target="theme/theme1.xml"/><Relationship Id="rId4" Type="http://schemas.openxmlformats.org/officeDocument/2006/relationships/slide" Target="slides/slide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750888"/>
            <a:ext cx="2601913" cy="3757612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8817" y="4758866"/>
            <a:ext cx="5510530" cy="45084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971" tIns="91971" rIns="91971" bIns="91971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2248433761"/>
      </p:ext>
    </p:extLst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15"/>
          <p:cNvSpPr txBox="1"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15"/>
          <p:cNvSpPr txBox="1"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1pPr>
            <a:lvl2pPr lvl="1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/>
            </a:lvl2pPr>
            <a:lvl3pPr lvl="2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/>
            </a:lvl3pPr>
            <a:lvl4pPr lvl="3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4pPr>
            <a:lvl5pPr lvl="4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5pPr>
            <a:lvl6pPr lvl="5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6pPr>
            <a:lvl7pPr lvl="6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7pPr>
            <a:lvl8pPr lvl="7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8pPr>
            <a:lvl9pPr lvl="8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9pPr>
          </a:lstStyle>
          <a:p>
            <a:endParaRPr/>
          </a:p>
        </p:txBody>
      </p:sp>
      <p:sp>
        <p:nvSpPr>
          <p:cNvPr id="23" name="Google Shape;23;p15"/>
          <p:cNvSpPr txBox="1">
            <a:spLocks noGrp="1"/>
          </p:cNvSpPr>
          <p:nvPr>
            <p:ph type="dt" idx="10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15"/>
          <p:cNvSpPr txBox="1">
            <a:spLocks noGrp="1"/>
          </p:cNvSpPr>
          <p:nvPr>
            <p:ph type="ftr" idx="11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15"/>
          <p:cNvSpPr txBox="1">
            <a:spLocks noGrp="1"/>
          </p:cNvSpPr>
          <p:nvPr>
            <p:ph type="sldNum" idx="12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17"/>
          <p:cNvSpPr txBox="1"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17"/>
          <p:cNvSpPr txBox="1"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181" lvl="0" indent="-228591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>
                <a:solidFill>
                  <a:schemeClr val="dk1"/>
                </a:solidFill>
              </a:defRPr>
            </a:lvl1pPr>
            <a:lvl2pPr marL="914361" lvl="1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 sz="1500">
                <a:solidFill>
                  <a:srgbClr val="888888"/>
                </a:solidFill>
              </a:defRPr>
            </a:lvl2pPr>
            <a:lvl3pPr marL="1371543" lvl="2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350"/>
              <a:buNone/>
              <a:defRPr sz="1350">
                <a:solidFill>
                  <a:srgbClr val="888888"/>
                </a:solidFill>
              </a:defRPr>
            </a:lvl3pPr>
            <a:lvl4pPr marL="1828724" lvl="3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4pPr>
            <a:lvl5pPr marL="2285904" lvl="4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5pPr>
            <a:lvl6pPr marL="2743085" lvl="5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6pPr>
            <a:lvl7pPr marL="3200266" lvl="6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7pPr>
            <a:lvl8pPr marL="3657447" lvl="7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8pPr>
            <a:lvl9pPr marL="4114628" lvl="8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5" name="Google Shape;35;p17"/>
          <p:cNvSpPr txBox="1">
            <a:spLocks noGrp="1"/>
          </p:cNvSpPr>
          <p:nvPr>
            <p:ph type="dt" idx="10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17"/>
          <p:cNvSpPr txBox="1">
            <a:spLocks noGrp="1"/>
          </p:cNvSpPr>
          <p:nvPr>
            <p:ph type="ftr" idx="11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7" name="Google Shape;37;p17"/>
          <p:cNvSpPr txBox="1">
            <a:spLocks noGrp="1"/>
          </p:cNvSpPr>
          <p:nvPr>
            <p:ph type="sldNum" idx="12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Google Shape;39;p18"/>
          <p:cNvSpPr txBox="1"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0" name="Google Shape;40;p18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181" lvl="0" indent="-342886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361" lvl="1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543" lvl="2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724" lvl="3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5904" lvl="4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085" lvl="5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266" lvl="6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447" lvl="7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628" lvl="8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1" name="Google Shape;41;p18"/>
          <p:cNvSpPr txBox="1">
            <a:spLocks noGrp="1"/>
          </p:cNvSpPr>
          <p:nvPr>
            <p:ph type="body" idx="2"/>
          </p:nvPr>
        </p:nvSpPr>
        <p:spPr>
          <a:xfrm>
            <a:off x="3471863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181" lvl="0" indent="-342886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361" lvl="1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543" lvl="2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724" lvl="3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5904" lvl="4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085" lvl="5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266" lvl="6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447" lvl="7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628" lvl="8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18"/>
          <p:cNvSpPr txBox="1">
            <a:spLocks noGrp="1"/>
          </p:cNvSpPr>
          <p:nvPr>
            <p:ph type="dt" idx="10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18"/>
          <p:cNvSpPr txBox="1">
            <a:spLocks noGrp="1"/>
          </p:cNvSpPr>
          <p:nvPr>
            <p:ph type="ftr" idx="11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18"/>
          <p:cNvSpPr txBox="1">
            <a:spLocks noGrp="1"/>
          </p:cNvSpPr>
          <p:nvPr>
            <p:ph type="sldNum" idx="12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19"/>
          <p:cNvSpPr txBox="1"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9"/>
          <p:cNvSpPr txBox="1"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181" lvl="0" indent="-228591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361" lvl="1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543" lvl="2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724" lvl="3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5904" lvl="4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085" lvl="5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266" lvl="6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447" lvl="7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628" lvl="8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8" name="Google Shape;48;p19"/>
          <p:cNvSpPr txBox="1">
            <a:spLocks noGrp="1"/>
          </p:cNvSpPr>
          <p:nvPr>
            <p:ph type="body" idx="2"/>
          </p:nvPr>
        </p:nvSpPr>
        <p:spPr>
          <a:xfrm>
            <a:off x="472382" y="3618443"/>
            <a:ext cx="2901255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181" lvl="0" indent="-342886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361" lvl="1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543" lvl="2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724" lvl="3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5904" lvl="4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085" lvl="5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266" lvl="6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447" lvl="7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628" lvl="8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9" name="Google Shape;49;p19"/>
          <p:cNvSpPr txBox="1">
            <a:spLocks noGrp="1"/>
          </p:cNvSpPr>
          <p:nvPr>
            <p:ph type="body" idx="3"/>
          </p:nvPr>
        </p:nvSpPr>
        <p:spPr>
          <a:xfrm>
            <a:off x="3471864" y="2428348"/>
            <a:ext cx="2915543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181" lvl="0" indent="-228591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361" lvl="1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543" lvl="2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724" lvl="3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5904" lvl="4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085" lvl="5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266" lvl="6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447" lvl="7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628" lvl="8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50" name="Google Shape;50;p19"/>
          <p:cNvSpPr txBox="1">
            <a:spLocks noGrp="1"/>
          </p:cNvSpPr>
          <p:nvPr>
            <p:ph type="body" idx="4"/>
          </p:nvPr>
        </p:nvSpPr>
        <p:spPr>
          <a:xfrm>
            <a:off x="3471864" y="3618443"/>
            <a:ext cx="2915543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181" lvl="0" indent="-342886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361" lvl="1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543" lvl="2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724" lvl="3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5904" lvl="4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085" lvl="5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266" lvl="6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447" lvl="7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628" lvl="8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1" name="Google Shape;51;p19"/>
          <p:cNvSpPr txBox="1">
            <a:spLocks noGrp="1"/>
          </p:cNvSpPr>
          <p:nvPr>
            <p:ph type="dt" idx="10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9"/>
          <p:cNvSpPr txBox="1">
            <a:spLocks noGrp="1"/>
          </p:cNvSpPr>
          <p:nvPr>
            <p:ph type="ftr" idx="11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9"/>
          <p:cNvSpPr txBox="1">
            <a:spLocks noGrp="1"/>
          </p:cNvSpPr>
          <p:nvPr>
            <p:ph type="sldNum" idx="12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20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20"/>
          <p:cNvSpPr txBox="1">
            <a:spLocks noGrp="1"/>
          </p:cNvSpPr>
          <p:nvPr>
            <p:ph type="body" idx="1"/>
          </p:nvPr>
        </p:nvSpPr>
        <p:spPr>
          <a:xfrm>
            <a:off x="2915544" y="1426284"/>
            <a:ext cx="3471863" cy="70396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181" lvl="0" indent="-380984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361" lvl="1" indent="-36193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543" lvl="2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724" lvl="3" indent="-32383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5904" lvl="4" indent="-32383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085" lvl="5" indent="-32383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266" lvl="6" indent="-32383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447" lvl="7" indent="-32383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628" lvl="8" indent="-32383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57" name="Google Shape;57;p20"/>
          <p:cNvSpPr txBox="1">
            <a:spLocks noGrp="1"/>
          </p:cNvSpPr>
          <p:nvPr>
            <p:ph type="body" idx="2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181" lvl="0" indent="-228591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361" lvl="1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543" lvl="2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724" lvl="3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5904" lvl="4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085" lvl="5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266" lvl="6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447" lvl="7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628" lvl="8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58" name="Google Shape;58;p20"/>
          <p:cNvSpPr txBox="1">
            <a:spLocks noGrp="1"/>
          </p:cNvSpPr>
          <p:nvPr>
            <p:ph type="dt" idx="10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20"/>
          <p:cNvSpPr txBox="1">
            <a:spLocks noGrp="1"/>
          </p:cNvSpPr>
          <p:nvPr>
            <p:ph type="ftr" idx="11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20"/>
          <p:cNvSpPr txBox="1">
            <a:spLocks noGrp="1"/>
          </p:cNvSpPr>
          <p:nvPr>
            <p:ph type="sldNum" idx="12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21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21"/>
          <p:cNvSpPr>
            <a:spLocks noGrp="1"/>
          </p:cNvSpPr>
          <p:nvPr>
            <p:ph type="pic" idx="2"/>
          </p:nvPr>
        </p:nvSpPr>
        <p:spPr>
          <a:xfrm>
            <a:off x="2915544" y="1426284"/>
            <a:ext cx="3471863" cy="70396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None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4" name="Google Shape;64;p21"/>
          <p:cNvSpPr txBox="1">
            <a:spLocks noGrp="1"/>
          </p:cNvSpPr>
          <p:nvPr>
            <p:ph type="body" idx="1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181" lvl="0" indent="-228591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361" lvl="1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543" lvl="2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724" lvl="3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5904" lvl="4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085" lvl="5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266" lvl="6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447" lvl="7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628" lvl="8" indent="-228591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5" name="Google Shape;65;p21"/>
          <p:cNvSpPr txBox="1">
            <a:spLocks noGrp="1"/>
          </p:cNvSpPr>
          <p:nvPr>
            <p:ph type="dt" idx="10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21"/>
          <p:cNvSpPr txBox="1">
            <a:spLocks noGrp="1"/>
          </p:cNvSpPr>
          <p:nvPr>
            <p:ph type="ftr" idx="11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21"/>
          <p:cNvSpPr txBox="1">
            <a:spLocks noGrp="1"/>
          </p:cNvSpPr>
          <p:nvPr>
            <p:ph type="sldNum" idx="12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22"/>
          <p:cNvSpPr txBox="1"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22"/>
          <p:cNvSpPr txBox="1">
            <a:spLocks noGrp="1"/>
          </p:cNvSpPr>
          <p:nvPr>
            <p:ph type="body" idx="1"/>
          </p:nvPr>
        </p:nvSpPr>
        <p:spPr>
          <a:xfrm rot="5400000">
            <a:off x="286367" y="2822136"/>
            <a:ext cx="6285266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181" lvl="0" indent="-342886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361" lvl="1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543" lvl="2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724" lvl="3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5904" lvl="4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085" lvl="5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266" lvl="6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447" lvl="7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628" lvl="8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22"/>
          <p:cNvSpPr txBox="1">
            <a:spLocks noGrp="1"/>
          </p:cNvSpPr>
          <p:nvPr>
            <p:ph type="dt" idx="10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22"/>
          <p:cNvSpPr txBox="1">
            <a:spLocks noGrp="1"/>
          </p:cNvSpPr>
          <p:nvPr>
            <p:ph type="ftr" idx="11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22"/>
          <p:cNvSpPr txBox="1">
            <a:spLocks noGrp="1"/>
          </p:cNvSpPr>
          <p:nvPr>
            <p:ph type="sldNum" idx="12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23"/>
          <p:cNvSpPr txBox="1">
            <a:spLocks noGrp="1"/>
          </p:cNvSpPr>
          <p:nvPr>
            <p:ph type="title"/>
          </p:nvPr>
        </p:nvSpPr>
        <p:spPr>
          <a:xfrm rot="5400000">
            <a:off x="1449697" y="3985465"/>
            <a:ext cx="839487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23"/>
          <p:cNvSpPr txBox="1">
            <a:spLocks noGrp="1"/>
          </p:cNvSpPr>
          <p:nvPr>
            <p:ph type="body" idx="1"/>
          </p:nvPr>
        </p:nvSpPr>
        <p:spPr>
          <a:xfrm rot="5400000">
            <a:off x="-1550678" y="2549571"/>
            <a:ext cx="839487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181" lvl="0" indent="-342886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361" lvl="1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543" lvl="2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724" lvl="3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5904" lvl="4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085" lvl="5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266" lvl="6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447" lvl="7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628" lvl="8" indent="-342886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23"/>
          <p:cNvSpPr txBox="1">
            <a:spLocks noGrp="1"/>
          </p:cNvSpPr>
          <p:nvPr>
            <p:ph type="dt" idx="10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23"/>
          <p:cNvSpPr txBox="1">
            <a:spLocks noGrp="1"/>
          </p:cNvSpPr>
          <p:nvPr>
            <p:ph type="ftr" idx="11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23"/>
          <p:cNvSpPr txBox="1">
            <a:spLocks noGrp="1"/>
          </p:cNvSpPr>
          <p:nvPr>
            <p:ph type="sldNum" idx="12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9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2"/>
          <p:cNvSpPr txBox="1"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12"/>
          <p:cNvSpPr txBox="1"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12"/>
          <p:cNvSpPr txBox="1">
            <a:spLocks noGrp="1"/>
          </p:cNvSpPr>
          <p:nvPr>
            <p:ph type="dt" idx="10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12"/>
          <p:cNvSpPr txBox="1">
            <a:spLocks noGrp="1"/>
          </p:cNvSpPr>
          <p:nvPr>
            <p:ph type="ftr" idx="11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12"/>
          <p:cNvSpPr txBox="1">
            <a:spLocks noGrp="1"/>
          </p:cNvSpPr>
          <p:nvPr>
            <p:ph type="sldNum" idx="12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1" r:id="rId1"/>
    <p:sldLayoutId id="2147483653" r:id="rId2"/>
    <p:sldLayoutId id="2147483654" r:id="rId3"/>
    <p:sldLayoutId id="2147483655" r:id="rId4"/>
    <p:sldLayoutId id="2147483656" r:id="rId5"/>
    <p:sldLayoutId id="2147483657" r:id="rId6"/>
    <p:sldLayoutId id="2147483658" r:id="rId7"/>
    <p:sldLayoutId id="2147483659" r:id="rId8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5">
            <a:extLst>
              <a:ext uri="{FF2B5EF4-FFF2-40B4-BE49-F238E27FC236}">
                <a16:creationId xmlns:a16="http://schemas.microsoft.com/office/drawing/2014/main" id="{2B5A4FD6-A208-495A-8819-6D55F7BC0DC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email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  <a14:imgEffect>
                      <a14:brightnessContrast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3556796" y="647700"/>
            <a:ext cx="2959100" cy="12623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13" name="表 12">
            <a:extLst>
              <a:ext uri="{FF2B5EF4-FFF2-40B4-BE49-F238E27FC236}">
                <a16:creationId xmlns:a16="http://schemas.microsoft.com/office/drawing/2014/main" id="{5D5EB1E9-129D-4A78-BDCA-2197DA2585A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31040048"/>
              </p:ext>
            </p:extLst>
          </p:nvPr>
        </p:nvGraphicFramePr>
        <p:xfrm>
          <a:off x="161925" y="1923338"/>
          <a:ext cx="6487317" cy="7678860"/>
        </p:xfrm>
        <a:graphic>
          <a:graphicData uri="http://schemas.openxmlformats.org/drawingml/2006/table">
            <a:tbl>
              <a:tblPr/>
              <a:tblGrid>
                <a:gridCol w="3507053">
                  <a:extLst>
                    <a:ext uri="{9D8B030D-6E8A-4147-A177-3AD203B41FA5}">
                      <a16:colId xmlns:a16="http://schemas.microsoft.com/office/drawing/2014/main" val="2880691369"/>
                    </a:ext>
                  </a:extLst>
                </a:gridCol>
                <a:gridCol w="425752">
                  <a:extLst>
                    <a:ext uri="{9D8B030D-6E8A-4147-A177-3AD203B41FA5}">
                      <a16:colId xmlns:a16="http://schemas.microsoft.com/office/drawing/2014/main" val="2213791741"/>
                    </a:ext>
                  </a:extLst>
                </a:gridCol>
                <a:gridCol w="425752">
                  <a:extLst>
                    <a:ext uri="{9D8B030D-6E8A-4147-A177-3AD203B41FA5}">
                      <a16:colId xmlns:a16="http://schemas.microsoft.com/office/drawing/2014/main" val="1725617980"/>
                    </a:ext>
                  </a:extLst>
                </a:gridCol>
                <a:gridCol w="425752">
                  <a:extLst>
                    <a:ext uri="{9D8B030D-6E8A-4147-A177-3AD203B41FA5}">
                      <a16:colId xmlns:a16="http://schemas.microsoft.com/office/drawing/2014/main" val="2077564822"/>
                    </a:ext>
                  </a:extLst>
                </a:gridCol>
                <a:gridCol w="425752">
                  <a:extLst>
                    <a:ext uri="{9D8B030D-6E8A-4147-A177-3AD203B41FA5}">
                      <a16:colId xmlns:a16="http://schemas.microsoft.com/office/drawing/2014/main" val="2901219155"/>
                    </a:ext>
                  </a:extLst>
                </a:gridCol>
                <a:gridCol w="425752">
                  <a:extLst>
                    <a:ext uri="{9D8B030D-6E8A-4147-A177-3AD203B41FA5}">
                      <a16:colId xmlns:a16="http://schemas.microsoft.com/office/drawing/2014/main" val="1164657353"/>
                    </a:ext>
                  </a:extLst>
                </a:gridCol>
                <a:gridCol w="425752">
                  <a:extLst>
                    <a:ext uri="{9D8B030D-6E8A-4147-A177-3AD203B41FA5}">
                      <a16:colId xmlns:a16="http://schemas.microsoft.com/office/drawing/2014/main" val="606413731"/>
                    </a:ext>
                  </a:extLst>
                </a:gridCol>
                <a:gridCol w="425752">
                  <a:extLst>
                    <a:ext uri="{9D8B030D-6E8A-4147-A177-3AD203B41FA5}">
                      <a16:colId xmlns:a16="http://schemas.microsoft.com/office/drawing/2014/main" val="2847746766"/>
                    </a:ext>
                  </a:extLst>
                </a:gridCol>
              </a:tblGrid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anonical_Pathways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TP63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TXBP4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KDR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TP53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D274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TUBB3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TMN1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22327397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G</a:t>
                      </a:r>
                      <a:r>
                        <a:rPr lang="el-GR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α</a:t>
                      </a:r>
                      <a:r>
                        <a:rPr lang="en-US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_Signaling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F98C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3EAF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E3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13911568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G</a:t>
                      </a:r>
                      <a:r>
                        <a:rPr lang="el-GR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α</a:t>
                      </a:r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E3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79ED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3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F0F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1F4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30989002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Neuroprotective_Role_of_THOP1_in_Alzheimer's_Disease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9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3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77175177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XR/RXR_Activation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3EAF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4DFF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9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CB8D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9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EF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E3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05983296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NAD_Salvage_Pathway_II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F0F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DC4E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1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4152005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ole_of_RIG1-like_Receptors_in_Antiviral_Innate_Immunity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0D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7A9D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6268053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ntrinsic_Prothrombin_Activation_Pathway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7A9D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72800947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etinoic_acid_Mediated_Apoptosis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89FD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24790927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Thyroid_Hormone_Metabolism_II_(via_Conjugation_and/or_Degradation)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F98C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7272431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ermatan_Sulfate_Biosynthesis_(Late_Stages)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E3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EBAD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CE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34877547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cetone_Degradation_I_(to_Methylglyoxal)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8B5D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E3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93708803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Glucocorticoid_Biosynthesis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5CA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06367868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Bupropion_Degradation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EBAD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98029581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alvage_Pathways_of_Pyrimidine_Ribonucleotides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EA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1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9CCE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EBAD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6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2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8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26005772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Fcγ_Receptor-mediated_Phagocytosis_in_Macrophages_and_Monocytes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99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E3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9CDE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CB8D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2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EF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67680153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erotonin_Degradation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09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F98C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FE7F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4B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0D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00787023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ole_of_PI3K/AKT_Signaling_in_the_Pathogenesis_of_Influenza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8A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39CC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E3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DE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8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65867602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Opioid_Signaling_Pathway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3D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EA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AD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3DFF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3D4E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1F4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AE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35189691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70S6K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B0B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1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B3B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E3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C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AD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02089261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Glioblastoma_Multiforme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7F8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B3B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9A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E3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BD9E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4F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8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60561791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TOR_Signaling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7F8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8C8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9A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5CA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6E1F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95259859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Nitric_Oxide_Signaling_in_the_Cardiovascular_System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69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99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0D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BFE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4DFF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2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40847592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hoA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9A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4A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DE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3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E5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05490910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uperpathway_of_Inositol_Phosphate_Compounds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1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69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8D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1C7E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7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F0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04693946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-phosphoinositide_Biosynthesis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4A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8A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4D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1C7E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8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5F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F0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13815244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perm_Motility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5E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AC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9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BFE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DF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A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F2F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65096979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-myo-inositol-5-phosphate_Metabolism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9C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B3B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1C7E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2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CC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6E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33644284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-phosphoinositide_Degradation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3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B3B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C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EBAD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CD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C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1F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18504913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-myo-inositol_(1,4,5,6)-Tetrakisphosphate_Biosynthesis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4D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E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C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EBAD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CD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3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1F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07471987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-myo-inositol_(3,4,5,6)-tetrakisphosphate_Biosynthesis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4D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E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C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EBAD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CD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3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1F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20139350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L-17A_Signaling_in_Airway_Cells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8A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0D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5CA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EF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F2F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97270739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FGF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EA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C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DE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DC4E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E3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0E8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EF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6966587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Ovarian_Cancer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848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4A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DC4E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9CDE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1DD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E5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96258687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GNRH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B1B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4C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DC4E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7C0E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FF3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D1E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86472230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Endothelin-1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B1B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DE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4C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2BDD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3D4E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5F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6E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97787356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L-3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8A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9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5CA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DA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3F5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5EC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14908847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opamine-DARPP32_Feedback_in_cAMP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DD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4D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F2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3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EE7F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5F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EE7F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17464753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ynaptic_Long_Term_Potentiation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0D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4C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F0F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1C7E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1D2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5F7F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EE7F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78194428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D28_Signaling_in_T_Helper_Cells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717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C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EBAD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9CDE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F3F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97671187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G</a:t>
                      </a:r>
                      <a:r>
                        <a:rPr lang="el-GR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α</a:t>
                      </a:r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q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787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9A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DE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2BDD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BD9E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6C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E5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42052724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ole_of_Pattern_Recognition_Receptors_in_Recognition_of_Bacteria_and_Viruses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8A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4B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1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B1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3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5E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9E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32521940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ole_of_NFAT_in_Cardiac_Hypertrophy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7F8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AC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4D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7A9D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CCFE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EF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2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11752081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hemokine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99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1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EBAD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9CCE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0E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F2F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43181360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G_Beta_Gamma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7F8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4A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2A6D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1D2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3F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43056834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elaxin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49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5CA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1D2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6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CE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03295504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etinoate_Biosynthesis_I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0D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DC4E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3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9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81586089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Growth_Hormone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E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BFE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1C7E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DD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CE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15267088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REB_Signaling_in_Neurons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CA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AC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9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EBAD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AC2E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5F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6E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20944882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ndrogen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0D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1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C2E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BFE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2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9E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77098731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I3K_Signaling_in_B_Lymphocytes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B1B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0D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9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D8E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0C7E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1E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5E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69742093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pelin_Cardiomyocyte_Signaling_Pathway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8A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0D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E3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1C7E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4C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AC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91732149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cute_Myeloid_Leukemia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757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4A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0D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F0F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0E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1668030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NF-</a:t>
                      </a:r>
                      <a:r>
                        <a:rPr lang="el-GR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κ</a:t>
                      </a:r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B_Activation_by_Viruses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8C8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4A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0D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B3B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F2F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08116545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Telomerase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848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1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4B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DE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3DFF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F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65233418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4-3-3-mediated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848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9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F0F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AC2E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EC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3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86343945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ryl_Hydrocarbon_Receptor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4A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FE7F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C2E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0D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A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27687239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eath_Receptor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FA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E3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FD1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F0F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98030889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yridoxal_5'-phosphate_Salvage_Pathway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8A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1C7E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E3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5F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F0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6952126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egulation_of_eIF4_and_p70S6K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FA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0D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2E9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0E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84041659"/>
                  </a:ext>
                </a:extLst>
              </a:tr>
            </a:tbl>
          </a:graphicData>
        </a:graphic>
      </p:graphicFrame>
      <p:sp>
        <p:nvSpPr>
          <p:cNvPr id="14" name="Google Shape;84;p1">
            <a:extLst>
              <a:ext uri="{FF2B5EF4-FFF2-40B4-BE49-F238E27FC236}">
                <a16:creationId xmlns:a16="http://schemas.microsoft.com/office/drawing/2014/main" id="{A0A424CA-798F-46B5-A997-61AC45235974}"/>
              </a:ext>
            </a:extLst>
          </p:cNvPr>
          <p:cNvSpPr txBox="1"/>
          <p:nvPr/>
        </p:nvSpPr>
        <p:spPr>
          <a:xfrm>
            <a:off x="0" y="0"/>
            <a:ext cx="4038600" cy="64629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r>
              <a:rPr lang="en-US" altLang="ja-JP" sz="18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Additional</a:t>
            </a:r>
            <a:r>
              <a:rPr lang="ja-JP" altLang="en-US" sz="18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 </a:t>
            </a:r>
            <a:r>
              <a:rPr lang="en-US" altLang="ja-JP" sz="1800" b="1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file 8</a:t>
            </a:r>
            <a:r>
              <a:rPr lang="en-US" sz="1800" b="1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.</a:t>
            </a:r>
            <a:endParaRPr lang="en-US" sz="1800" b="1" dirty="0">
              <a:solidFill>
                <a:schemeClr val="dk1"/>
              </a:solidFill>
              <a:latin typeface="Times New Roman" panose="02020603050405020304" pitchFamily="18" charset="0"/>
              <a:ea typeface="Calibri"/>
              <a:cs typeface="Times New Roman" panose="02020603050405020304" pitchFamily="18" charset="0"/>
              <a:sym typeface="Calibri"/>
            </a:endParaRPr>
          </a:p>
          <a:p>
            <a:r>
              <a:rPr lang="en-US" sz="18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 (continued)</a:t>
            </a:r>
            <a:endParaRPr sz="1800" b="1" dirty="0">
              <a:solidFill>
                <a:schemeClr val="dk1"/>
              </a:solidFill>
              <a:latin typeface="Times New Roman" panose="02020603050405020304" pitchFamily="18" charset="0"/>
              <a:ea typeface="Calibri"/>
              <a:cs typeface="Times New Roman" panose="02020603050405020304" pitchFamily="18" charset="0"/>
              <a:sym typeface="Calibri"/>
            </a:endParaRPr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E06D5314-71A1-47CE-B22E-141FCCEFCE63}"/>
              </a:ext>
            </a:extLst>
          </p:cNvPr>
          <p:cNvSpPr/>
          <p:nvPr/>
        </p:nvSpPr>
        <p:spPr>
          <a:xfrm rot="16200000">
            <a:off x="3226535" y="1155761"/>
            <a:ext cx="53412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ight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956A8CBC-B0D5-4D00-A1ED-6D48C5D88205}"/>
              </a:ext>
            </a:extLst>
          </p:cNvPr>
          <p:cNvSpPr/>
          <p:nvPr/>
        </p:nvSpPr>
        <p:spPr>
          <a:xfrm>
            <a:off x="4258296" y="376168"/>
            <a:ext cx="143981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onical Pathways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6419B552-F6AF-442B-B70F-2D94A63428C7}"/>
              </a:ext>
            </a:extLst>
          </p:cNvPr>
          <p:cNvSpPr/>
          <p:nvPr/>
        </p:nvSpPr>
        <p:spPr>
          <a:xfrm>
            <a:off x="5883533" y="745669"/>
            <a:ext cx="74090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ta_distance</a:t>
            </a:r>
            <a:endParaRPr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870FFF45-5E9F-4D03-8E9F-22C48859FF0B}"/>
              </a:ext>
            </a:extLst>
          </p:cNvPr>
          <p:cNvSpPr/>
          <p:nvPr/>
        </p:nvSpPr>
        <p:spPr>
          <a:xfrm>
            <a:off x="5743740" y="857921"/>
            <a:ext cx="1083951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clust</a:t>
            </a:r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*, "complete")</a:t>
            </a:r>
            <a:endParaRPr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820990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5">
            <a:extLst>
              <a:ext uri="{FF2B5EF4-FFF2-40B4-BE49-F238E27FC236}">
                <a16:creationId xmlns:a16="http://schemas.microsoft.com/office/drawing/2014/main" id="{A9FEA39D-706A-4A37-AE4A-062E41A7682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email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  <a14:imgEffect>
                      <a14:brightnessContrast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3556796" y="609600"/>
            <a:ext cx="2959100" cy="12623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7" name="表 6">
            <a:extLst>
              <a:ext uri="{FF2B5EF4-FFF2-40B4-BE49-F238E27FC236}">
                <a16:creationId xmlns:a16="http://schemas.microsoft.com/office/drawing/2014/main" id="{34627881-A991-46F4-BB9C-8CE73E56BAD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78438064"/>
              </p:ext>
            </p:extLst>
          </p:nvPr>
        </p:nvGraphicFramePr>
        <p:xfrm>
          <a:off x="381696" y="1898919"/>
          <a:ext cx="6223797" cy="7556940"/>
        </p:xfrm>
        <a:graphic>
          <a:graphicData uri="http://schemas.openxmlformats.org/drawingml/2006/table">
            <a:tbl>
              <a:tblPr/>
              <a:tblGrid>
                <a:gridCol w="3364591">
                  <a:extLst>
                    <a:ext uri="{9D8B030D-6E8A-4147-A177-3AD203B41FA5}">
                      <a16:colId xmlns:a16="http://schemas.microsoft.com/office/drawing/2014/main" val="1673444241"/>
                    </a:ext>
                  </a:extLst>
                </a:gridCol>
                <a:gridCol w="408458">
                  <a:extLst>
                    <a:ext uri="{9D8B030D-6E8A-4147-A177-3AD203B41FA5}">
                      <a16:colId xmlns:a16="http://schemas.microsoft.com/office/drawing/2014/main" val="2907708728"/>
                    </a:ext>
                  </a:extLst>
                </a:gridCol>
                <a:gridCol w="408458">
                  <a:extLst>
                    <a:ext uri="{9D8B030D-6E8A-4147-A177-3AD203B41FA5}">
                      <a16:colId xmlns:a16="http://schemas.microsoft.com/office/drawing/2014/main" val="1905230974"/>
                    </a:ext>
                  </a:extLst>
                </a:gridCol>
                <a:gridCol w="408458">
                  <a:extLst>
                    <a:ext uri="{9D8B030D-6E8A-4147-A177-3AD203B41FA5}">
                      <a16:colId xmlns:a16="http://schemas.microsoft.com/office/drawing/2014/main" val="166756639"/>
                    </a:ext>
                  </a:extLst>
                </a:gridCol>
                <a:gridCol w="408458">
                  <a:extLst>
                    <a:ext uri="{9D8B030D-6E8A-4147-A177-3AD203B41FA5}">
                      <a16:colId xmlns:a16="http://schemas.microsoft.com/office/drawing/2014/main" val="913750806"/>
                    </a:ext>
                  </a:extLst>
                </a:gridCol>
                <a:gridCol w="408458">
                  <a:extLst>
                    <a:ext uri="{9D8B030D-6E8A-4147-A177-3AD203B41FA5}">
                      <a16:colId xmlns:a16="http://schemas.microsoft.com/office/drawing/2014/main" val="2716481512"/>
                    </a:ext>
                  </a:extLst>
                </a:gridCol>
                <a:gridCol w="408458">
                  <a:extLst>
                    <a:ext uri="{9D8B030D-6E8A-4147-A177-3AD203B41FA5}">
                      <a16:colId xmlns:a16="http://schemas.microsoft.com/office/drawing/2014/main" val="2956884762"/>
                    </a:ext>
                  </a:extLst>
                </a:gridCol>
                <a:gridCol w="408458">
                  <a:extLst>
                    <a:ext uri="{9D8B030D-6E8A-4147-A177-3AD203B41FA5}">
                      <a16:colId xmlns:a16="http://schemas.microsoft.com/office/drawing/2014/main" val="1439777627"/>
                    </a:ext>
                  </a:extLst>
                </a:gridCol>
              </a:tblGrid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anonical_Pathways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TP63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TXBP4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KDR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TP53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D274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TUBB3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TMN1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54321623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I3K/AKT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0D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CA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5D5E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6E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68557869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grin_Interactions_at_Neuromuscular_Junction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4A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ED0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0D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4D5E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C2E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57307393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NOS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FA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8D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D8E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23040013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ngiopoietin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4C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9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0E8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4D5E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49065846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ErbB4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7F8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ACDE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6CB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28042028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ERK5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FA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69DC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4D5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83727322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VEGF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8A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0E8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0BBD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5E0F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30868807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D27_Signaling_in_Lymphocytes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9A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D8E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5CA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D8E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45382266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Neuregulin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707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0D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5E0F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0E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89070663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ancreatic_Adenocarcinoma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8D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6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EF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76745898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L-7_Signaling_Pathway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7F8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4EBF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8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B3B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37909755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Huntington's_Disease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868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8D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0E8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3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C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AC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97417267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Type_II_Diabetes_Mellitus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69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1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ED0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5D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E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99833783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Ethanol_Degradation_IV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1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1A5D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1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86321495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elatonin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1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9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6CB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7C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CE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95338853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nduction_of_Apoptosis_by_HIV1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B3B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AA0D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0E8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5458197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UVA-Induced_MAPK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9A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6CB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5E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13999785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TWEAK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E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C2E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44016684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EDF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9C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ED0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8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D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48008714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l-GR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α-</a:t>
                      </a:r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drenergic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1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0E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0E8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21189560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tRNA_Charg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1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0E8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D8E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55635571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eptin_Signaling_in_Obesity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59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AC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9E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24995466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Glycolysis_I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787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13783233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Non-Small_Cell_Lung_Cancer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787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F0F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88043853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mall_Cell_Lung_Cancer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8A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4EBF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E3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0E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5902293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TNFR2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4B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3558624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-1BB_Signaling_in_T_Lymphocytes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4A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9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4600515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emodeling_of_Epithelial_Adherens_Junctions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FA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4EBF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4814241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Gluconeogenesis_I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FA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2234731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VEGF_Family_Ligand-Receptor_Interactions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787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4A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9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DE6F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4EBF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7246468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Thrombopoietin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787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1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9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D8E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63950186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IF_Regulation_of_Innate_Immunity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FA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1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8D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60501265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IF-mediated_Glucocorticoid_Regulation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FA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4A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9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51105562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L-9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878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4A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9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5081529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Thrombin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7E8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8C8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E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1C7E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0F3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BE4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39976066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EGF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878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0D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AA0D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BE4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8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5721283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phingosine-1-phosphate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6A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9A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AC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FBBD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3DFF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0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60736849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enal_Cell_Carcinoma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7F8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1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0D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C2E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5CA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DDE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23682489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ANK_Signaling_in_Osteoclasts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7D7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1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8D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FBBD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1E9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F0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8721658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FLT3_Signaling_in_Hematopoietic_Progenitor_Cells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8C8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4A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4EBF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3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F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45862885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Glioma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7F8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1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6CB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1DEF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0E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85984567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ErbB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7D7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1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6CB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1DEF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D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27215345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Estrogen-Dependent_Breast_Cancer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59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1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BFE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ACDE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12058760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Toll-like_Receptor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99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9A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6CB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4EBF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0E8F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74229555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GM-CSF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8E9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4A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BFE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BE4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34314226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Ephrin_B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9A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0D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C2E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F0F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6CB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57332499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pelin_Endothelial_Signaling_Pathway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B0B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C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9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ED0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5B4D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4EBF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CC4E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30483018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BMP_signaling_pathway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4C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0D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0D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8B5D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ED0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6CB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59340247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GDNF_Family_Ligand-Receptor_Interactions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FA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1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0D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8B5D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ACDE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8AA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4125369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ntiproliferative_Role_of_Somatostatin_Receptor_2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707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DD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C2E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16415599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2Y_Purigenic_Receptor_Signaling_Pathway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69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DE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8D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EC5E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4F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F0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82664045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rolactin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7F8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0D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C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39BC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6E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4EBF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15347155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ldosterone_Signaling_in_Epithelial_Cells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FA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1C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8D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39BC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8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85901914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DGF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878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9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8D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AA0D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2D3E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D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59099287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Endocannabinoid_Developing_Neuron_Pathway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4A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C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8D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D97C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7D7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8E3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66216754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ouse_Embryonic_Stem_Cell_Pluripotency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8E9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0D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BFE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1E9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71403528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D40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FA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0D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C2E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DD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D8E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80382266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nsulin_Receptor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49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8D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BFE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6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1DE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35305370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L-2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7F8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9C2E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F0F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EF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72396091"/>
                  </a:ext>
                </a:extLst>
              </a:tr>
            </a:tbl>
          </a:graphicData>
        </a:graphic>
      </p:graphicFrame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68CA11B6-146A-417C-A4BB-388B6DE45A90}"/>
              </a:ext>
            </a:extLst>
          </p:cNvPr>
          <p:cNvSpPr/>
          <p:nvPr/>
        </p:nvSpPr>
        <p:spPr>
          <a:xfrm rot="16200000">
            <a:off x="3226535" y="1155761"/>
            <a:ext cx="53412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ight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4958B98F-59F4-4BCE-B2BD-1362AC4976A2}"/>
              </a:ext>
            </a:extLst>
          </p:cNvPr>
          <p:cNvSpPr/>
          <p:nvPr/>
        </p:nvSpPr>
        <p:spPr>
          <a:xfrm>
            <a:off x="4258296" y="376168"/>
            <a:ext cx="143981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onical Pathways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33B568FB-6319-4550-A99F-BF823F1F27B8}"/>
              </a:ext>
            </a:extLst>
          </p:cNvPr>
          <p:cNvSpPr/>
          <p:nvPr/>
        </p:nvSpPr>
        <p:spPr>
          <a:xfrm>
            <a:off x="5883533" y="745669"/>
            <a:ext cx="74090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ta_distance</a:t>
            </a:r>
            <a:endParaRPr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F05E19F7-48BB-4EBF-AF1E-A79B9DFA98F8}"/>
              </a:ext>
            </a:extLst>
          </p:cNvPr>
          <p:cNvSpPr/>
          <p:nvPr/>
        </p:nvSpPr>
        <p:spPr>
          <a:xfrm>
            <a:off x="5743740" y="857921"/>
            <a:ext cx="1083951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clust</a:t>
            </a:r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*, "complete")</a:t>
            </a:r>
            <a:endParaRPr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Google Shape;84;p1">
            <a:extLst>
              <a:ext uri="{FF2B5EF4-FFF2-40B4-BE49-F238E27FC236}">
                <a16:creationId xmlns:a16="http://schemas.microsoft.com/office/drawing/2014/main" id="{FED44AD1-5E9F-4680-AABE-D0B0FB667E60}"/>
              </a:ext>
            </a:extLst>
          </p:cNvPr>
          <p:cNvSpPr txBox="1"/>
          <p:nvPr/>
        </p:nvSpPr>
        <p:spPr>
          <a:xfrm>
            <a:off x="0" y="0"/>
            <a:ext cx="4038600" cy="64629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r>
              <a:rPr lang="en-US" altLang="ja-JP" sz="18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Additional</a:t>
            </a:r>
            <a:r>
              <a:rPr lang="ja-JP" altLang="en-US" sz="18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 </a:t>
            </a:r>
            <a:r>
              <a:rPr lang="en-US" altLang="ja-JP" sz="18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file 8</a:t>
            </a:r>
            <a:r>
              <a:rPr lang="en-US" sz="18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.</a:t>
            </a:r>
          </a:p>
          <a:p>
            <a:r>
              <a:rPr lang="en-US" sz="18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 (continued)</a:t>
            </a:r>
            <a:endParaRPr sz="1800" b="1" dirty="0">
              <a:solidFill>
                <a:schemeClr val="dk1"/>
              </a:solidFill>
              <a:latin typeface="Times New Roman" panose="02020603050405020304" pitchFamily="18" charset="0"/>
              <a:ea typeface="Calibri"/>
              <a:cs typeface="Times New Roman" panose="02020603050405020304" pitchFamily="18" charset="0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5568741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5">
            <a:extLst>
              <a:ext uri="{FF2B5EF4-FFF2-40B4-BE49-F238E27FC236}">
                <a16:creationId xmlns:a16="http://schemas.microsoft.com/office/drawing/2014/main" id="{1411C0DF-BCB6-4138-B957-7E40F6ABCBF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email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  <a14:imgEffect>
                      <a14:brightnessContrast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3556796" y="647700"/>
            <a:ext cx="2959100" cy="12623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6" name="表 5">
            <a:extLst>
              <a:ext uri="{FF2B5EF4-FFF2-40B4-BE49-F238E27FC236}">
                <a16:creationId xmlns:a16="http://schemas.microsoft.com/office/drawing/2014/main" id="{A9311A5D-8CFA-458E-9F16-5D150B3537E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89773039"/>
              </p:ext>
            </p:extLst>
          </p:nvPr>
        </p:nvGraphicFramePr>
        <p:xfrm>
          <a:off x="198041" y="1910045"/>
          <a:ext cx="6534944" cy="7556940"/>
        </p:xfrm>
        <a:graphic>
          <a:graphicData uri="http://schemas.openxmlformats.org/drawingml/2006/table">
            <a:tbl>
              <a:tblPr/>
              <a:tblGrid>
                <a:gridCol w="3532798">
                  <a:extLst>
                    <a:ext uri="{9D8B030D-6E8A-4147-A177-3AD203B41FA5}">
                      <a16:colId xmlns:a16="http://schemas.microsoft.com/office/drawing/2014/main" val="388560268"/>
                    </a:ext>
                  </a:extLst>
                </a:gridCol>
                <a:gridCol w="428878">
                  <a:extLst>
                    <a:ext uri="{9D8B030D-6E8A-4147-A177-3AD203B41FA5}">
                      <a16:colId xmlns:a16="http://schemas.microsoft.com/office/drawing/2014/main" val="2869985081"/>
                    </a:ext>
                  </a:extLst>
                </a:gridCol>
                <a:gridCol w="428878">
                  <a:extLst>
                    <a:ext uri="{9D8B030D-6E8A-4147-A177-3AD203B41FA5}">
                      <a16:colId xmlns:a16="http://schemas.microsoft.com/office/drawing/2014/main" val="634118991"/>
                    </a:ext>
                  </a:extLst>
                </a:gridCol>
                <a:gridCol w="428878">
                  <a:extLst>
                    <a:ext uri="{9D8B030D-6E8A-4147-A177-3AD203B41FA5}">
                      <a16:colId xmlns:a16="http://schemas.microsoft.com/office/drawing/2014/main" val="3516440856"/>
                    </a:ext>
                  </a:extLst>
                </a:gridCol>
                <a:gridCol w="428878">
                  <a:extLst>
                    <a:ext uri="{9D8B030D-6E8A-4147-A177-3AD203B41FA5}">
                      <a16:colId xmlns:a16="http://schemas.microsoft.com/office/drawing/2014/main" val="870329847"/>
                    </a:ext>
                  </a:extLst>
                </a:gridCol>
                <a:gridCol w="428878">
                  <a:extLst>
                    <a:ext uri="{9D8B030D-6E8A-4147-A177-3AD203B41FA5}">
                      <a16:colId xmlns:a16="http://schemas.microsoft.com/office/drawing/2014/main" val="4197869829"/>
                    </a:ext>
                  </a:extLst>
                </a:gridCol>
                <a:gridCol w="428878">
                  <a:extLst>
                    <a:ext uri="{9D8B030D-6E8A-4147-A177-3AD203B41FA5}">
                      <a16:colId xmlns:a16="http://schemas.microsoft.com/office/drawing/2014/main" val="3526495724"/>
                    </a:ext>
                  </a:extLst>
                </a:gridCol>
                <a:gridCol w="428878">
                  <a:extLst>
                    <a:ext uri="{9D8B030D-6E8A-4147-A177-3AD203B41FA5}">
                      <a16:colId xmlns:a16="http://schemas.microsoft.com/office/drawing/2014/main" val="3421803457"/>
                    </a:ext>
                  </a:extLst>
                </a:gridCol>
              </a:tblGrid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anonical_Pathways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TP63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TXBP4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KDR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TP53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D274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TUBB3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TMN1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9960742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JAK/Stat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757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1F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1F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8B6D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1F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6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94984981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Endometrial_Cancer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707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8B6D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DDB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E5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4132307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NTF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8696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6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FAF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F8F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01170812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ErbB2-ErbB3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7D7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EE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6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5ECF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F8F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10821690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Lymphotoxin_</a:t>
                      </a:r>
                      <a:r>
                        <a:rPr lang="el-GR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β_</a:t>
                      </a:r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eceptor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19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DC5E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1E9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F8F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76731497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elanoma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808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DC5E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5ECF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F8F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92507569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TCA_Cycle_II_(Eukaryotic)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C97C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19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78070655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PAR</a:t>
                      </a:r>
                      <a:r>
                        <a:rPr lang="el-GR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α/</a:t>
                      </a:r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XR</a:t>
                      </a:r>
                      <a:r>
                        <a:rPr lang="el-GR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α_</a:t>
                      </a:r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ctivation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C1E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EE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6C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F8F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8D8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DD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34617362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TEN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C1E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1F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FBF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9A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0D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82250531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umoylation_Pathway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E5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DC5E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1F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FBF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8B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1F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60858051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ell_Cycle:_G1/S_Checkpoint_Regulation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1F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4DFF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DC5E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B9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BCEE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F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09851302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FKFB4_Signaling_Pathway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D3D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19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1F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1BCD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CFE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70501557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pelin_Pancreas_Signaling_Pathway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3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1F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6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EA3D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11309221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olanic_Acid_Building_Blocks_Biosynthesis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EA3D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DC5E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65632092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pelin_Cardiac_Fibroblast_Signaling_Pathway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CFE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4DF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95184488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myloid_Process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F2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CFE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6E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66585587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uperpathway_of_Cholesterol_Biosynthesis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592C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592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36157734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holesterol_Biosynthesis_III_(via_Desmosterol)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D8CC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D8CC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05456500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holesterol_Biosynthesis_I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D8CC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D8CC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03422146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holesterol_Biosynthesis_II_(via_24,25-dihydrolanosterol)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D8CC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D8CC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67557350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HIPPO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6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6C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1B1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EE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39714069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Endocannabinoid_Cancer_Inhibition_Pathway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AB7D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1F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3F6F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EE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AB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1F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1DE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84693820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53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8B6D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1F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4DFF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1F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EDB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F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86962964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yclins_and_Cell_Cycle_Regulation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EE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8B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E5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3F6F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CA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8E9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85242232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Estrogen-mediated_S-phase_Entry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69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AA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26808299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L-22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98D8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B9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81000365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ell_Cycle:_G2/M_DNA_Damage_Checkpoint_Regulation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6C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1F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4B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0C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42129245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Granzyme_B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B9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21407903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tearate_Biosynthesis_I_(Animals)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1F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6C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A0A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24656222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ole_of_Wnt/GSK-3β_Signaling_in_the_Pathogenesis_of_Influenza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EE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6C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19221256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ell_Cycle_Regulation_by_BTG_Family_Proteins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0C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0C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82912428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BAG2_Signaling_Pathway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8B6D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0C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1F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1F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50058357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itotic_Roles_of_Polo-Like_Kinase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EE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592C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1F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1F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57809924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yrimidine_Ribonucleotides_De_Novo_Biosynthesis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6C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6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BB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49304704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pt-BR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urine_Nucleotides_De_Novo_Biosynthesis_II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A9B9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56466558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egulation_of_Cellular_Mechanics_by_Calpain_Protease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ED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1F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B4B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E5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4DF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04007322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ardiac_</a:t>
                      </a:r>
                      <a:r>
                        <a:rPr lang="el-GR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β-</a:t>
                      </a:r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drenergic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1F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EE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F2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0C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FE8F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F8F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66864405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opamine_Receptor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DC5E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6C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F2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21063077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rotein_Kinase_A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EEF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AE4F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1B1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B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E5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84737755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Valine_Degradation_I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EA3D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13552847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Isoleucine_Degradation_I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C97C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07439978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Fatty_Acid_</a:t>
                      </a:r>
                      <a:r>
                        <a:rPr lang="el-GR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β-</a:t>
                      </a:r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oxidation_I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EE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6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1E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EE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6584070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ole_of_CHK_Proteins_in_Cell_Cycle_Checkpoint_Control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3F6F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6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8DB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1F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38615536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poptosis_Signaling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1F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1F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1F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AC2E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FE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7F8F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66626896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Hypoxia_Signaling_in_the_Cardiovascular_System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EE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1F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8B6D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65976298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FAT10_Cancer_Signaling_Pathway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FF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1E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74710357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FAT10_Signaling_Pathway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6E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4832144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omplement_System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DCFE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7479395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D-myo-inositol_(1,4,5)-Trisphosphate_Biosynthesis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1E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6E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45806619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Wnt/Ca+_pathway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F2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4DFF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BF0F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1F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33852438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Superpathway_of_Methionine_Degradation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DEE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4DFF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F2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44194301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hosphatidylglycerol_Biosynthesis_II_(Non-plastidic)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6C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25217657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DP-diacylglycerol_Biosynthesis_I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6C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51088186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D-myo-inositol_Hexakisphosphate_Biosynthesis_II_(Mammalian)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BCED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58406169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pelin_Muscle_Signaling_Pathway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3F6F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F2F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02166616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Guanosine_Nucleotides_Degradation_III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F2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05086019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Urate_Biosynthesis/Inosine_5'-phosphate_Degradation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F2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67683952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urine_Nucleotides_Degradation_II_(Aerobic)</a:t>
                      </a: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F2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F1F4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39250744"/>
                  </a:ext>
                </a:extLst>
              </a:tr>
              <a:tr h="1047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Adenosine_Nucleotides_Degradation_II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F2FA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4029" marR="4029" marT="40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17762113"/>
                  </a:ext>
                </a:extLst>
              </a:tr>
            </a:tbl>
          </a:graphicData>
        </a:graphic>
      </p:graphicFrame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ED0D6377-EB52-454A-8EBD-4AB9F543A0F6}"/>
              </a:ext>
            </a:extLst>
          </p:cNvPr>
          <p:cNvSpPr/>
          <p:nvPr/>
        </p:nvSpPr>
        <p:spPr>
          <a:xfrm rot="16200000">
            <a:off x="3226535" y="1155761"/>
            <a:ext cx="53412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ight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5428C3DE-0C5B-45C5-BFDB-4EC446817B66}"/>
              </a:ext>
            </a:extLst>
          </p:cNvPr>
          <p:cNvSpPr/>
          <p:nvPr/>
        </p:nvSpPr>
        <p:spPr>
          <a:xfrm>
            <a:off x="4258296" y="376168"/>
            <a:ext cx="143981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onical Pathways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4D024F85-68A7-4087-85BC-BD7C9188ED60}"/>
              </a:ext>
            </a:extLst>
          </p:cNvPr>
          <p:cNvSpPr/>
          <p:nvPr/>
        </p:nvSpPr>
        <p:spPr>
          <a:xfrm>
            <a:off x="5883533" y="745669"/>
            <a:ext cx="74090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ta_distance</a:t>
            </a:r>
            <a:endParaRPr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9A26B421-7A97-4EAD-9A4E-350FBC4C19A8}"/>
              </a:ext>
            </a:extLst>
          </p:cNvPr>
          <p:cNvSpPr/>
          <p:nvPr/>
        </p:nvSpPr>
        <p:spPr>
          <a:xfrm>
            <a:off x="5743740" y="857921"/>
            <a:ext cx="1083951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clust</a:t>
            </a:r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*, "complete")</a:t>
            </a:r>
            <a:endParaRPr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Google Shape;84;p1">
            <a:extLst>
              <a:ext uri="{FF2B5EF4-FFF2-40B4-BE49-F238E27FC236}">
                <a16:creationId xmlns:a16="http://schemas.microsoft.com/office/drawing/2014/main" id="{94632B24-3259-43D0-A585-25B2EF33DFE6}"/>
              </a:ext>
            </a:extLst>
          </p:cNvPr>
          <p:cNvSpPr txBox="1"/>
          <p:nvPr/>
        </p:nvSpPr>
        <p:spPr>
          <a:xfrm>
            <a:off x="0" y="0"/>
            <a:ext cx="4038600" cy="64629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r>
              <a:rPr lang="en-US" altLang="ja-JP" sz="18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Additional</a:t>
            </a:r>
            <a:r>
              <a:rPr lang="ja-JP" altLang="en-US" sz="18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 </a:t>
            </a:r>
            <a:r>
              <a:rPr lang="en-US" altLang="ja-JP" sz="18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file 8</a:t>
            </a:r>
            <a:r>
              <a:rPr lang="en-US" sz="18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.</a:t>
            </a:r>
          </a:p>
          <a:p>
            <a:r>
              <a:rPr lang="en-US" sz="1800" b="1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 (continued)</a:t>
            </a:r>
            <a:endParaRPr sz="1800" b="1" dirty="0">
              <a:solidFill>
                <a:schemeClr val="dk1"/>
              </a:solidFill>
              <a:latin typeface="Times New Roman" panose="02020603050405020304" pitchFamily="18" charset="0"/>
              <a:ea typeface="Calibri"/>
              <a:cs typeface="Times New Roman" panose="02020603050405020304" pitchFamily="18" charset="0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7644981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890</TotalTime>
  <Words>1245</Words>
  <Application>Microsoft Office PowerPoint</Application>
  <PresentationFormat>A4 210 x 297 mm</PresentationFormat>
  <Paragraphs>219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7" baseType="lpstr">
      <vt:lpstr>Arial</vt:lpstr>
      <vt:lpstr>Calibri</vt:lpstr>
      <vt:lpstr>Times New Roman</vt:lpstr>
      <vt:lpstr>Office Theme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Bilguun Erkhem-Ochir</dc:creator>
  <cp:lastModifiedBy>西山 正彦</cp:lastModifiedBy>
  <cp:revision>85</cp:revision>
  <cp:lastPrinted>2020-09-06T06:25:43Z</cp:lastPrinted>
  <dcterms:created xsi:type="dcterms:W3CDTF">2018-05-17T03:09:07Z</dcterms:created>
  <dcterms:modified xsi:type="dcterms:W3CDTF">2020-09-06T06:27:23Z</dcterms:modified>
</cp:coreProperties>
</file>